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jpeg" ContentType="image/jpeg"/>
  <Override PartName="/ppt/media/image3.jpeg" ContentType="image/jpeg"/>
  <Override PartName="/ppt/media/image4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584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46F9BD-7F47-4CD8-8230-8F8671C433D6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Rectangle 1031"/>
          <p:cNvSpPr/>
          <p:nvPr/>
        </p:nvSpPr>
        <p:spPr>
          <a:xfrm>
            <a:off x="3886200" y="868680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690F3D6-368E-4AF5-8CAE-B0441D4FC07B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1" name="PlaceHolder 2"/>
          <p:cNvSpPr>
            <a:spLocks noGrp="1"/>
          </p:cNvSpPr>
          <p:nvPr>
            <p:ph type="body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A8BA2-3B23-43E0-A456-A108A06EB5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8D8C6B-EFF6-4E1A-8F3C-8372076B1A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66922F-4C2A-47BE-9522-E9A3A2778A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57C67-4B30-4AFA-A858-F4D52ECFDF5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EFC816-183F-4534-8841-5895D3E649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E18094-354E-4A06-90F7-59CDABA75C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5F27F1-8B44-4D45-A175-794D5B55A9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5B3B1A-E12C-4B6A-A000-DFB1ABB7DC8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48510C-6CC1-48A3-8736-379C31E7A1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48734A-863C-4DDD-9AF1-B297F5E09D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9B6B4D-1224-484A-8C54-56B294EC95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7348C4-50C5-49F4-81FD-5064D10176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2C0A5BF-0EE4-402A-B6D5-19FC2D3B02E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<Relationship Id="rId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75960" y="75960"/>
            <a:ext cx="6629400" cy="5331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4: delayed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P. acnes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induced effects develop in the combined absence of TLR9, IL-1R and IL-18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5"/>
          <p:cNvSpPr/>
          <p:nvPr/>
        </p:nvSpPr>
        <p:spPr>
          <a:xfrm>
            <a:off x="78840" y="604980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C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5"/>
          <p:cNvSpPr/>
          <p:nvPr/>
        </p:nvSpPr>
        <p:spPr>
          <a:xfrm>
            <a:off x="78840" y="320040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B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Picture 15" descr=""/>
          <p:cNvPicPr/>
          <p:nvPr/>
        </p:nvPicPr>
        <p:blipFill>
          <a:blip r:embed="rId1"/>
          <a:stretch/>
        </p:blipFill>
        <p:spPr>
          <a:xfrm>
            <a:off x="76320" y="641520"/>
            <a:ext cx="2133360" cy="2484360"/>
          </a:xfrm>
          <a:prstGeom prst="rect">
            <a:avLst/>
          </a:prstGeom>
          <a:ln w="0">
            <a:noFill/>
          </a:ln>
        </p:spPr>
      </p:pic>
      <p:sp>
        <p:nvSpPr>
          <p:cNvPr id="52" name="Rectangle 14"/>
          <p:cNvSpPr/>
          <p:nvPr/>
        </p:nvSpPr>
        <p:spPr>
          <a:xfrm>
            <a:off x="78120" y="41112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A.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17" descr=""/>
          <p:cNvPicPr/>
          <p:nvPr/>
        </p:nvPicPr>
        <p:blipFill>
          <a:blip r:embed="rId2"/>
          <a:stretch/>
        </p:blipFill>
        <p:spPr>
          <a:xfrm>
            <a:off x="2362320" y="641520"/>
            <a:ext cx="2133360" cy="248436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8" descr=""/>
          <p:cNvPicPr/>
          <p:nvPr/>
        </p:nvPicPr>
        <p:blipFill>
          <a:blip r:embed="rId3"/>
          <a:stretch/>
        </p:blipFill>
        <p:spPr>
          <a:xfrm>
            <a:off x="4648320" y="641520"/>
            <a:ext cx="2133360" cy="248436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9" descr="Fig.S4B TNF IL1R-TLR9.tif"/>
          <p:cNvPicPr/>
          <p:nvPr/>
        </p:nvPicPr>
        <p:blipFill>
          <a:blip r:embed="rId4"/>
          <a:srcRect l="0" t="0" r="5929" b="0"/>
          <a:stretch/>
        </p:blipFill>
        <p:spPr>
          <a:xfrm>
            <a:off x="677880" y="3395520"/>
            <a:ext cx="2141640" cy="27003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22" descr="Fig.S4B TNF IL18-TLR9.tif"/>
          <p:cNvPicPr/>
          <p:nvPr/>
        </p:nvPicPr>
        <p:blipFill>
          <a:blip r:embed="rId5"/>
          <a:srcRect l="3982" t="1789" r="3982" b="-7147"/>
          <a:stretch/>
        </p:blipFill>
        <p:spPr>
          <a:xfrm>
            <a:off x="3697200" y="3382920"/>
            <a:ext cx="2170080" cy="269244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26" descr="Fig.S4C TNF.tif"/>
          <p:cNvPicPr/>
          <p:nvPr/>
        </p:nvPicPr>
        <p:blipFill>
          <a:blip r:embed="rId6"/>
          <a:srcRect l="2010" t="0" r="8845" b="0"/>
          <a:stretch/>
        </p:blipFill>
        <p:spPr>
          <a:xfrm>
            <a:off x="669960" y="6367320"/>
            <a:ext cx="2149560" cy="270036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29" descr="Fig.S4C IFN.tif"/>
          <p:cNvPicPr/>
          <p:nvPr/>
        </p:nvPicPr>
        <p:blipFill>
          <a:blip r:embed="rId7"/>
          <a:srcRect l="3916" t="0" r="8616" b="0"/>
          <a:stretch/>
        </p:blipFill>
        <p:spPr>
          <a:xfrm>
            <a:off x="3625920" y="6367320"/>
            <a:ext cx="2165400" cy="2700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03T02:37:38Z</dcterms:created>
  <dc:creator>mac165</dc:creator>
  <dc:description/>
  <dc:language>en-US</dc:language>
  <cp:lastModifiedBy>domis</cp:lastModifiedBy>
  <cp:lastPrinted>2011-01-11T23:27:35Z</cp:lastPrinted>
  <dcterms:modified xsi:type="dcterms:W3CDTF">2012-05-24T18:16:15Z</dcterms:modified>
  <cp:revision>345</cp:revision>
  <dc:subject/>
  <dc:title>PowerPoint Presentation</dc:title>
</cp:coreProperties>
</file>